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 varScale="1">
        <p:scale>
          <a:sx n="73" d="100"/>
          <a:sy n="73" d="100"/>
        </p:scale>
        <p:origin x="272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2687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2956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0653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595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2787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4263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6280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4633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14022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61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834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4E97E8-8B44-4F27-8F46-2ADEB2FD51BF}" type="datetimeFigureOut">
              <a:rPr kumimoji="1" lang="ja-JP" altLang="en-US" smtClean="0"/>
              <a:t>2019/6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077978-B8A2-499D-8376-6FDCBAC9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6585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FA1AF3A4-05B9-4A71-8F87-34645F9E5D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5994879"/>
              </p:ext>
            </p:extLst>
          </p:nvPr>
        </p:nvGraphicFramePr>
        <p:xfrm>
          <a:off x="1143000" y="5478468"/>
          <a:ext cx="4853940" cy="769620"/>
        </p:xfrm>
        <a:graphic>
          <a:graphicData uri="http://schemas.openxmlformats.org/drawingml/2006/table">
            <a:tbl>
              <a:tblPr/>
              <a:tblGrid>
                <a:gridCol w="4853940">
                  <a:extLst>
                    <a:ext uri="{9D8B030D-6E8A-4147-A177-3AD203B41FA5}">
                      <a16:colId xmlns:a16="http://schemas.microsoft.com/office/drawing/2014/main" val="2487189524"/>
                    </a:ext>
                  </a:extLst>
                </a:gridCol>
              </a:tblGrid>
              <a:tr h="132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ater temperature : 11-12℃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25120"/>
                  </a:ext>
                </a:extLst>
              </a:tr>
              <a:tr h="1912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bservations were conducted from 17:00 to 8:00 under dark condi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1124843"/>
                  </a:ext>
                </a:extLst>
              </a:tr>
              <a:tr h="1321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ank size: φ445 mm, Water depth: 50 mm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9048491"/>
                  </a:ext>
                </a:extLst>
              </a:tr>
              <a:tr h="191284">
                <a:tc>
                  <a:txBody>
                    <a:bodyPr/>
                    <a:lstStyle/>
                    <a:p>
                      <a:pPr algn="l" fontAlgn="ctr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Video Cammera: DVSA10FHDIR, Kenko Tokina Corpor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0781530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D62F71AE-0545-4AD4-805F-3AF5030691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4776626"/>
              </p:ext>
            </p:extLst>
          </p:nvPr>
        </p:nvGraphicFramePr>
        <p:xfrm>
          <a:off x="1143000" y="1276350"/>
          <a:ext cx="6858000" cy="4305300"/>
        </p:xfrm>
        <a:graphic>
          <a:graphicData uri="http://schemas.openxmlformats.org/drawingml/2006/table">
            <a:tbl>
              <a:tblPr/>
              <a:tblGrid>
                <a:gridCol w="611298">
                  <a:extLst>
                    <a:ext uri="{9D8B030D-6E8A-4147-A177-3AD203B41FA5}">
                      <a16:colId xmlns:a16="http://schemas.microsoft.com/office/drawing/2014/main" val="1881982182"/>
                    </a:ext>
                  </a:extLst>
                </a:gridCol>
                <a:gridCol w="897844">
                  <a:extLst>
                    <a:ext uri="{9D8B030D-6E8A-4147-A177-3AD203B41FA5}">
                      <a16:colId xmlns:a16="http://schemas.microsoft.com/office/drawing/2014/main" val="3002211521"/>
                    </a:ext>
                  </a:extLst>
                </a:gridCol>
                <a:gridCol w="983808">
                  <a:extLst>
                    <a:ext uri="{9D8B030D-6E8A-4147-A177-3AD203B41FA5}">
                      <a16:colId xmlns:a16="http://schemas.microsoft.com/office/drawing/2014/main" val="224534788"/>
                    </a:ext>
                  </a:extLst>
                </a:gridCol>
                <a:gridCol w="1547348">
                  <a:extLst>
                    <a:ext uri="{9D8B030D-6E8A-4147-A177-3AD203B41FA5}">
                      <a16:colId xmlns:a16="http://schemas.microsoft.com/office/drawing/2014/main" val="575510352"/>
                    </a:ext>
                  </a:extLst>
                </a:gridCol>
                <a:gridCol w="1050669">
                  <a:extLst>
                    <a:ext uri="{9D8B030D-6E8A-4147-A177-3AD203B41FA5}">
                      <a16:colId xmlns:a16="http://schemas.microsoft.com/office/drawing/2014/main" val="2185500090"/>
                    </a:ext>
                  </a:extLst>
                </a:gridCol>
                <a:gridCol w="1767033">
                  <a:extLst>
                    <a:ext uri="{9D8B030D-6E8A-4147-A177-3AD203B41FA5}">
                      <a16:colId xmlns:a16="http://schemas.microsoft.com/office/drawing/2014/main" val="2496256063"/>
                    </a:ext>
                  </a:extLst>
                </a:gridCol>
              </a:tblGrid>
              <a:tr h="238125">
                <a:tc gridSpan="6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8886489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x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at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hell length (mm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height (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ocomotion distance (cm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859244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9.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.8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488258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1.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8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719419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5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.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9034402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2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.4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3901279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.8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5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1170666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1.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0704993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7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2093672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9.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6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2102652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3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1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4174248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8.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.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7662728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2.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.6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8085424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2.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0468000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4.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.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7739735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1/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2.4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.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1906354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ema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7/2/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2.8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5424911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50498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03721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9</TotalTime>
  <Words>141</Words>
  <Application>Microsoft Office PowerPoint</Application>
  <PresentationFormat>画面に合わせる (4:3)</PresentationFormat>
  <Paragraphs>10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本　有記雄</dc:creator>
  <cp:lastModifiedBy>松本　有記雄</cp:lastModifiedBy>
  <cp:revision>7</cp:revision>
  <dcterms:created xsi:type="dcterms:W3CDTF">2019-03-29T01:42:03Z</dcterms:created>
  <dcterms:modified xsi:type="dcterms:W3CDTF">2019-06-21T02:29:52Z</dcterms:modified>
</cp:coreProperties>
</file>